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CF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628"/>
    <p:restoredTop sz="94694"/>
  </p:normalViewPr>
  <p:slideViewPr>
    <p:cSldViewPr snapToGrid="0" snapToObjects="1">
      <p:cViewPr varScale="1">
        <p:scale>
          <a:sx n="86" d="100"/>
          <a:sy n="86" d="100"/>
        </p:scale>
        <p:origin x="2776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87496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81781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16634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87522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65953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53759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76569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43356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49759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1327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29378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89182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42FB6CC6-D1DC-774C-AE1D-7DFB18EE8E3A}"/>
              </a:ext>
            </a:extLst>
          </p:cNvPr>
          <p:cNvSpPr txBox="1"/>
          <p:nvPr/>
        </p:nvSpPr>
        <p:spPr>
          <a:xfrm>
            <a:off x="515314" y="3001297"/>
            <a:ext cx="527992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A comparison of anti-spike </a:t>
            </a:r>
            <a:r>
              <a:rPr lang="en-US" sz="1200" dirty="0" err="1"/>
              <a:t>titre</a:t>
            </a:r>
            <a:r>
              <a:rPr lang="en-US" sz="1200" dirty="0"/>
              <a:t> as measured by Roche in those who received the 2 doses on a standard interval compared to those donors who received it on an extended interval (p=0.0014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A3BD682-B58C-B946-B6A3-15A65AE24495}"/>
              </a:ext>
            </a:extLst>
          </p:cNvPr>
          <p:cNvSpPr txBox="1"/>
          <p:nvPr/>
        </p:nvSpPr>
        <p:spPr>
          <a:xfrm>
            <a:off x="419483" y="158094"/>
            <a:ext cx="3171750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Figure 2 </a:t>
            </a:r>
          </a:p>
          <a:p>
            <a:r>
              <a:rPr lang="en-US" sz="1200" dirty="0"/>
              <a:t>Comparison of antibody </a:t>
            </a:r>
            <a:r>
              <a:rPr lang="en-US" sz="1200" dirty="0" err="1"/>
              <a:t>titre</a:t>
            </a:r>
            <a:r>
              <a:rPr lang="en-US" sz="1200" dirty="0"/>
              <a:t> by vaccine interval 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1708AABD-5089-2340-8C72-B93FD9A853D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1323" y="700551"/>
            <a:ext cx="3047677" cy="23135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531319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923</TotalTime>
  <Words>46</Words>
  <Application>Microsoft Macintosh PowerPoint</Application>
  <PresentationFormat>A4 Paper (210x297 mm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len Parry (School of Immunity and Infection)</dc:creator>
  <cp:lastModifiedBy>Helen Parry (School of Immunity and Infection)</cp:lastModifiedBy>
  <cp:revision>85</cp:revision>
  <dcterms:created xsi:type="dcterms:W3CDTF">2021-08-29T12:31:11Z</dcterms:created>
  <dcterms:modified xsi:type="dcterms:W3CDTF">2021-10-10T20:15:58Z</dcterms:modified>
</cp:coreProperties>
</file>